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26"/>
          <a:stretch/>
        </p:blipFill>
        <p:spPr>
          <a:xfrm rot="16200000">
            <a:off x="2343410" y="2410636"/>
            <a:ext cx="5816257" cy="2940751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8990251" y="3515296"/>
            <a:ext cx="210393" cy="914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8730800" y="6484980"/>
            <a:ext cx="244948" cy="285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11888" y="3703921"/>
            <a:ext cx="3341264" cy="282917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 rot="16200000">
            <a:off x="3586237" y="6493798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419650" y="6506361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-218448" y="6191405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</a:p>
        </p:txBody>
      </p:sp>
      <p:sp>
        <p:nvSpPr>
          <p:cNvPr id="2" name="Rectangle 1"/>
          <p:cNvSpPr/>
          <p:nvPr/>
        </p:nvSpPr>
        <p:spPr>
          <a:xfrm rot="16200000">
            <a:off x="4573468" y="3189317"/>
            <a:ext cx="6096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. S5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top pharmacologics on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.</a:t>
            </a:r>
            <a:r>
              <a:rPr lang="en-US" sz="1200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hibition of proteasome ChT-like activity in MM cells and </a:t>
            </a:r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.</a:t>
            </a:r>
            <a:r>
              <a:rPr lang="en-US" sz="1200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M cell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viability.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66418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33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02:28Z</dcterms:modified>
</cp:coreProperties>
</file>